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D80F10-0AF3-478D-AF4E-7334CF8A016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FA3921-23CE-4F86-B6CA-AA5EC7C5444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2B2C14-4F11-4BD7-8C63-AD9E2C58A02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00B4F2-B56A-4148-B050-1F9E33F929D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A4B06B-0B3C-48D0-B5A3-33EBACB737F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222A5F-951F-4B8A-82FF-488D50BBA7B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7F393E-5CD4-469B-B61B-7DCF33D8FB0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9B843A-B644-4D04-8C90-A30C2CC3D2F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5104F0-3A4E-44D1-8930-AA614AEC3BD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480CDE-5A57-4787-B62B-71262895542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24C31F-49F8-4204-B9D8-D3B54F5A141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5AF1CD-2A84-41D6-8234-EBEE1C6AFC2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C27BC1A-9D16-42E2-9E39-C47C5A4E2048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38"/>
          <p:cNvSpPr/>
          <p:nvPr/>
        </p:nvSpPr>
        <p:spPr>
          <a:xfrm>
            <a:off x="3475080" y="5802480"/>
            <a:ext cx="2271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Supplemental figure 4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" name="Picture 5" descr=""/>
          <p:cNvPicPr/>
          <p:nvPr/>
        </p:nvPicPr>
        <p:blipFill>
          <a:blip r:embed="rId1"/>
          <a:stretch/>
        </p:blipFill>
        <p:spPr>
          <a:xfrm>
            <a:off x="3398760" y="1322280"/>
            <a:ext cx="2314800" cy="12798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43" name="TextBox 9"/>
          <p:cNvSpPr/>
          <p:nvPr/>
        </p:nvSpPr>
        <p:spPr>
          <a:xfrm>
            <a:off x="3546720" y="5251320"/>
            <a:ext cx="2094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1          2         3         4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TextBox 24"/>
          <p:cNvSpPr/>
          <p:nvPr/>
        </p:nvSpPr>
        <p:spPr>
          <a:xfrm>
            <a:off x="4125240" y="1060560"/>
            <a:ext cx="269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+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TextBox 25"/>
          <p:cNvSpPr/>
          <p:nvPr/>
        </p:nvSpPr>
        <p:spPr>
          <a:xfrm>
            <a:off x="5295240" y="1058760"/>
            <a:ext cx="269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+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TextBox 26"/>
          <p:cNvSpPr/>
          <p:nvPr/>
        </p:nvSpPr>
        <p:spPr>
          <a:xfrm>
            <a:off x="3544200" y="992160"/>
            <a:ext cx="269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_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TextBox 27"/>
          <p:cNvSpPr/>
          <p:nvPr/>
        </p:nvSpPr>
        <p:spPr>
          <a:xfrm>
            <a:off x="4728600" y="992160"/>
            <a:ext cx="269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_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TextBox 28"/>
          <p:cNvSpPr/>
          <p:nvPr/>
        </p:nvSpPr>
        <p:spPr>
          <a:xfrm>
            <a:off x="4742640" y="822240"/>
            <a:ext cx="269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+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TextBox 29"/>
          <p:cNvSpPr/>
          <p:nvPr/>
        </p:nvSpPr>
        <p:spPr>
          <a:xfrm>
            <a:off x="5293800" y="819000"/>
            <a:ext cx="269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+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TextBox 30"/>
          <p:cNvSpPr/>
          <p:nvPr/>
        </p:nvSpPr>
        <p:spPr>
          <a:xfrm>
            <a:off x="3542760" y="752400"/>
            <a:ext cx="269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_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Box 31"/>
          <p:cNvSpPr/>
          <p:nvPr/>
        </p:nvSpPr>
        <p:spPr>
          <a:xfrm>
            <a:off x="4139640" y="752400"/>
            <a:ext cx="269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_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TextBox 32"/>
          <p:cNvSpPr/>
          <p:nvPr/>
        </p:nvSpPr>
        <p:spPr>
          <a:xfrm>
            <a:off x="5638680" y="1098720"/>
            <a:ext cx="753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Lapatinib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TextBox 33"/>
          <p:cNvSpPr/>
          <p:nvPr/>
        </p:nvSpPr>
        <p:spPr>
          <a:xfrm>
            <a:off x="5628960" y="846000"/>
            <a:ext cx="770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HER2-VI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TextBox 34"/>
          <p:cNvSpPr/>
          <p:nvPr/>
        </p:nvSpPr>
        <p:spPr>
          <a:xfrm>
            <a:off x="5750640" y="2971800"/>
            <a:ext cx="7066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IP: HER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IB: HER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TextBox 35"/>
          <p:cNvSpPr/>
          <p:nvPr/>
        </p:nvSpPr>
        <p:spPr>
          <a:xfrm>
            <a:off x="5748840" y="1650960"/>
            <a:ext cx="9532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IP: HER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IB: Ubiquiti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Straight Connector 20"/>
          <p:cNvSpPr/>
          <p:nvPr/>
        </p:nvSpPr>
        <p:spPr>
          <a:xfrm>
            <a:off x="3559320" y="861840"/>
            <a:ext cx="20113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TextBox 22"/>
          <p:cNvSpPr/>
          <p:nvPr/>
        </p:nvSpPr>
        <p:spPr>
          <a:xfrm>
            <a:off x="4071600" y="611280"/>
            <a:ext cx="1043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10µM MG13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8" name="Picture 3" descr=""/>
          <p:cNvPicPr/>
          <p:nvPr/>
        </p:nvPicPr>
        <p:blipFill>
          <a:blip r:embed="rId2"/>
          <a:stretch/>
        </p:blipFill>
        <p:spPr>
          <a:xfrm>
            <a:off x="3398760" y="3952800"/>
            <a:ext cx="2314800" cy="12794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59" name="Picture 3" descr=""/>
          <p:cNvPicPr/>
          <p:nvPr/>
        </p:nvPicPr>
        <p:blipFill>
          <a:blip r:embed="rId3"/>
          <a:stretch/>
        </p:blipFill>
        <p:spPr>
          <a:xfrm>
            <a:off x="3398760" y="2641680"/>
            <a:ext cx="2313000" cy="12808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60" name="TextBox 3"/>
          <p:cNvSpPr/>
          <p:nvPr/>
        </p:nvSpPr>
        <p:spPr>
          <a:xfrm>
            <a:off x="5747760" y="4402080"/>
            <a:ext cx="8056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ell lysat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IB: HER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4-25T20:25:12Z</dcterms:created>
  <dc:creator>Xiu-Rong Ren, Ph.D.</dc:creator>
  <dc:description/>
  <dc:language>en-US</dc:language>
  <cp:lastModifiedBy>Xiu-Rong Ren, Ph.D.</cp:lastModifiedBy>
  <dcterms:modified xsi:type="dcterms:W3CDTF">2012-05-10T02:12:24Z</dcterms:modified>
  <cp:revision>6</cp:revision>
  <dc:subject/>
  <dc:title>PowerPoint Presentation</dc:title>
</cp:coreProperties>
</file>